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47D0E5-4FE0-4795-B0C2-946CD02634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EAD1D3-BE28-4CBF-863D-5A1B21E31D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5E94FD-176A-4C72-92FC-D51D3AE6B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1EA85E-5EB1-4607-9E3A-80A5EC23BB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A3E0EF-C4F1-432D-9D91-E752B2163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0773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C99BC9-0917-4853-9D92-EC586CCABB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31EE59-4FAB-46C0-9E63-02150F4EA1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FDD341-9E9F-4A64-9D45-3C471249E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8B2342-5711-4B0C-9072-316F641E9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028118-E02F-4314-BB63-D04203BED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745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39E56C-4119-4C32-B57F-0BA87781D8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A91420-DF66-457D-91C8-0456510495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D1760A-6A23-4234-B133-69080C3A8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ABF10C-5D0D-4A46-9461-39EE28252F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BDA447-C278-4729-BE97-D7CABA047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7561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9BD8E-35E0-442B-9334-6ADEB754B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5516EE-15B3-4031-8F8A-4553185132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BD49BD-6DFF-40FB-9E12-394CB0700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6D14D-FA37-446A-9444-5FAAD7516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8864C-507A-470F-9E33-5E45243EF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7101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8148E-F542-4E23-AA26-318BC1D45D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F9D8A6-32D7-4E74-BBC9-429AA6ADF2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38B293-4D7B-485B-B9EA-42AF4F5FD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BFB15-DAF0-4921-9C44-F5A5477E2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D6C353-EEDC-49C8-BF09-04B622F8D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665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E2B2D2-52EC-478A-B61A-0F49249571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C96A00-CBEE-4DFE-8ABB-61179C242F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D72BA1-69A1-4E9F-B4BA-B727BC90D2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4FE30A-0F91-4E4D-9A12-0DC4126DB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43CF36-51EE-4F3C-97A5-E78C43DF2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A0A803-C08E-446D-AF8E-141C307037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232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0C16EB-8216-4664-B7E8-F74A19805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875794-69DF-4F06-9E08-7C405F56B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4E0633-40C7-434A-A49E-7C0675ECFF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E915D1-316B-493C-9DA3-9BB0C58E94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453EF8-F0F5-4E53-B1C0-0A75FF6134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37CCA1-C557-45D8-B508-B5A028279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F0AB25-1048-4E0F-8528-3DAA8DE04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56CCF0-CA82-47FA-870D-903C5D5C3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370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5F7A55-4661-4BB2-9782-503401261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F85AF8-EEBC-4656-AFCE-D4A8A7173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0A380B-C30A-4CF3-9611-19351DC1B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1AF8C2-6CBB-4261-BC38-0AEB2B4D9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931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B0E1EB-62FF-4986-9F3E-1CC21AE79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73192B-2C2E-43A0-AADD-F3E5AE66B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4870ED-5508-4C02-9FFD-A021A2307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5516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D0954-4867-494F-8D63-754AAF3A91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2629C7-3C3F-4B9F-BC54-844888936F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B32014-1A6B-42A0-96C1-EDD21388D2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B25B3C-F13E-4BC0-8729-94FC98CB6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F2D67D-3985-4E09-BB7E-2448ED8AF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E6B457-2959-4667-B926-0AB0A8E78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3953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AA1831-2474-44C5-95B6-A8E27E4FF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676AB2-3BFF-4137-B4F4-738F200BA2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3E0EB9-0329-4964-AFD5-79FDFF00B7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6ADB91-ACB1-43E9-80DF-CCAF4A335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1B01DE-7F6E-4E26-9369-425F33D41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D66A96-E84C-4BB7-9C2C-81BC7CFE2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984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E5052E-6A0D-47D9-BF9F-69F04BB3B0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A4FA5A-D055-43AB-BB18-A4FB32DECA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8F171D-B1AC-4FD0-AABD-1E211DEC96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ED3B0-5A51-4C73-B516-35B58D7AB2F6}" type="datetimeFigureOut">
              <a:rPr lang="en-GB" smtClean="0"/>
              <a:t>09/04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80A1C9-1961-447B-8F59-98A4033965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021476-6AB8-408B-AC25-37859F303E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6D71C-B8E8-4DC4-AAAD-F891F2C89F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830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0238031-E20E-490F-B7DB-8AA3E9CBB5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3267540"/>
              </p:ext>
            </p:extLst>
          </p:nvPr>
        </p:nvGraphicFramePr>
        <p:xfrm>
          <a:off x="716930" y="2439409"/>
          <a:ext cx="10946565" cy="35431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98317">
                  <a:extLst>
                    <a:ext uri="{9D8B030D-6E8A-4147-A177-3AD203B41FA5}">
                      <a16:colId xmlns:a16="http://schemas.microsoft.com/office/drawing/2014/main" val="3240987850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3951333854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1780385534"/>
                    </a:ext>
                  </a:extLst>
                </a:gridCol>
                <a:gridCol w="921066">
                  <a:extLst>
                    <a:ext uri="{9D8B030D-6E8A-4147-A177-3AD203B41FA5}">
                      <a16:colId xmlns:a16="http://schemas.microsoft.com/office/drawing/2014/main" val="1343031560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1981846070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750740158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1897524215"/>
                    </a:ext>
                  </a:extLst>
                </a:gridCol>
                <a:gridCol w="921066">
                  <a:extLst>
                    <a:ext uri="{9D8B030D-6E8A-4147-A177-3AD203B41FA5}">
                      <a16:colId xmlns:a16="http://schemas.microsoft.com/office/drawing/2014/main" val="3762144564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3106167556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3274064798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2703081029"/>
                    </a:ext>
                  </a:extLst>
                </a:gridCol>
                <a:gridCol w="921066">
                  <a:extLst>
                    <a:ext uri="{9D8B030D-6E8A-4147-A177-3AD203B41FA5}">
                      <a16:colId xmlns:a16="http://schemas.microsoft.com/office/drawing/2014/main" val="2990206912"/>
                    </a:ext>
                  </a:extLst>
                </a:gridCol>
                <a:gridCol w="709450">
                  <a:extLst>
                    <a:ext uri="{9D8B030D-6E8A-4147-A177-3AD203B41FA5}">
                      <a16:colId xmlns:a16="http://schemas.microsoft.com/office/drawing/2014/main" val="1648075830"/>
                    </a:ext>
                  </a:extLst>
                </a:gridCol>
              </a:tblGrid>
              <a:tr h="608509">
                <a:tc>
                  <a:txBody>
                    <a:bodyPr/>
                    <a:lstStyle/>
                    <a:p>
                      <a:endParaRPr lang="en-GB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LSM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77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LSM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59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R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LSM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534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LSM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556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R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LSM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239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LSM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=260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R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95% CI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2914875"/>
                  </a:ext>
                </a:extLst>
              </a:tr>
              <a:tr h="4000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osite</a:t>
                      </a:r>
                      <a:endParaRPr lang="en-GB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1-1.42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72-1.01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57-0.94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6835311"/>
                  </a:ext>
                </a:extLst>
              </a:tr>
              <a:tr h="4000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w onset T2DM</a:t>
                      </a:r>
                      <a:endParaRPr lang="en-GB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17-1.42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07-1.02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680347"/>
                  </a:ext>
                </a:extLst>
              </a:tr>
              <a:tr h="4000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w onset IGT</a:t>
                      </a:r>
                      <a:endParaRPr lang="en-GB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31-1.68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-1.07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39-0.92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0900623"/>
                  </a:ext>
                </a:extLst>
              </a:tr>
              <a:tr h="4000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w onset IFG</a:t>
                      </a:r>
                      <a:endParaRPr lang="en-GB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66-2.29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92-1.65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75-1.77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4564375"/>
                  </a:ext>
                </a:extLst>
              </a:tr>
              <a:tr h="4000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w onset dysglycemia</a:t>
                      </a:r>
                      <a:endParaRPr lang="en-GB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7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73-1.9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81-1.20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56-0.97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548692"/>
                  </a:ext>
                </a:extLst>
              </a:tr>
              <a:tr h="40009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pertension</a:t>
                      </a:r>
                      <a:endParaRPr lang="en-GB" sz="14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18-1.01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3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49-0.91)</a:t>
                      </a:r>
                      <a:endParaRPr lang="en-GB" sz="1400" b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0.25-0.76)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  <a:endParaRPr lang="en-GB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36" marR="4163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9937073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C8F5674B-9904-412C-A8BC-C8AE01932EC7}"/>
              </a:ext>
            </a:extLst>
          </p:cNvPr>
          <p:cNvSpPr/>
          <p:nvPr/>
        </p:nvSpPr>
        <p:spPr>
          <a:xfrm>
            <a:off x="473649" y="599846"/>
            <a:ext cx="11371606" cy="9440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1. 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pragmatic lifestyle modification (P-LSM) as compared to control lifestyle modification (C-LSM) on the incidence of the primary cardio-metabolic composite endpoint and its selected individual components in 1725 participants below 18 years of age stratified by age groups  </a:t>
            </a:r>
            <a:endParaRPr lang="en-GB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BCCAE53-B66A-48AA-A167-E5D618D39D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6002076"/>
              </p:ext>
            </p:extLst>
          </p:nvPr>
        </p:nvGraphicFramePr>
        <p:xfrm>
          <a:off x="2517639" y="1967091"/>
          <a:ext cx="9134669" cy="47110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044262">
                  <a:extLst>
                    <a:ext uri="{9D8B030D-6E8A-4147-A177-3AD203B41FA5}">
                      <a16:colId xmlns:a16="http://schemas.microsoft.com/office/drawing/2014/main" val="2679553985"/>
                    </a:ext>
                  </a:extLst>
                </a:gridCol>
                <a:gridCol w="3053593">
                  <a:extLst>
                    <a:ext uri="{9D8B030D-6E8A-4147-A177-3AD203B41FA5}">
                      <a16:colId xmlns:a16="http://schemas.microsoft.com/office/drawing/2014/main" val="592094918"/>
                    </a:ext>
                  </a:extLst>
                </a:gridCol>
                <a:gridCol w="3036814">
                  <a:extLst>
                    <a:ext uri="{9D8B030D-6E8A-4147-A177-3AD203B41FA5}">
                      <a16:colId xmlns:a16="http://schemas.microsoft.com/office/drawing/2014/main" val="55607177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to 10 years of age 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36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to 14 years of age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090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to 18 years of age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499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93758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543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266</Words>
  <Application>Microsoft Office PowerPoint</Application>
  <PresentationFormat>Widescreen</PresentationFormat>
  <Paragraphs>1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alliedde, J</dc:creator>
  <cp:lastModifiedBy>Karalliedde, J</cp:lastModifiedBy>
  <cp:revision>5</cp:revision>
  <dcterms:created xsi:type="dcterms:W3CDTF">2019-04-02T14:36:41Z</dcterms:created>
  <dcterms:modified xsi:type="dcterms:W3CDTF">2019-04-09T11:51:23Z</dcterms:modified>
</cp:coreProperties>
</file>